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6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096072-2412-753B-0399-45DAE32D85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6D2C2C9-47AC-A6BD-08C7-B40CCA7E0E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ECD6E6-F8CD-D38E-3A32-9FAFFAF38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D2030D-BBA0-954D-72FD-25D93378E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F8B38C-898B-956A-C9F0-8753B3995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0265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FFEA2E-B3AC-AD1A-0801-212805932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B8C7374-F40D-7847-DD2D-1E3925CDE9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A3D509-1A00-0C39-7C1B-57B5FD63C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FF46CA-5992-1F0D-1091-711C0CE51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D089D5-6EA0-CFC4-A16F-237AFE3BF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181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452C61F-2D20-B826-59C9-13C84B282C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4D8BCFB-EFEE-2496-D494-AB6286C704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9FBA25-15BC-DEA6-DFE1-4ADD4F2C6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0C1CFF-C4C8-7C15-A312-ABDBDD10E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BD16FC-E9D4-FC7A-2CD2-7276C95D5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1950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5424BF-525F-D179-DD35-C1316961E8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D92F9A-886A-6E6D-9914-12AD3BF308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95C200-43DE-5EE5-8282-47D6B050D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868F88-7AAE-8DC1-733F-E492143DB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ECF7F9-3540-21E0-791F-1FCF4A278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531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701C1B-0C28-FB8D-D7FA-2DE984E2B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B0E32E-4A80-5A63-B169-2ED1D11480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71B5ED-9B9F-AC82-20C4-A940E92AD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E0A1D8-FBC7-72E6-84EC-4ADB0CFF1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E1200D-1556-6811-6469-0A66B98A9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667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A23B38-36E3-E635-CB73-F96507B923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372153E-9748-C67D-E047-B934AC9CA0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BAC630-3D91-6ACE-0169-81E75CFCD0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83605A-27DA-0081-8E1A-65B8F9740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3AF1B6-F849-EDFE-2855-8998CC5A8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D1E383-69D9-1E86-F613-8C1037F8F6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3446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30421B-26E9-47DA-077D-6CF773B5F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CD9080-9140-5CC2-C591-555AFF902B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353CEC-556A-5580-4848-CFD70BD6FB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0BC1240-D74B-A92C-21F9-DAD258B123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15CF989-E5FF-A2F8-4DD8-1585A04B0E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CB07DC8-35A1-54D9-1F7B-49A649C05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5AFF0B-5D55-2859-8C0E-F84ED491F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685334A-E892-C669-DBC5-AAAEB0DB9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597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94B15E-511D-261D-872C-F996C85FA4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528B891-CE61-1BB6-38FA-ECF63016F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E3E9922-6B00-D038-2F39-0EEDD8A10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F659275-08CF-A604-9B84-C8E3BC2A1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8454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6F2DD5D-2A2E-24AA-52F9-2219C7F51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89624DE-DE26-C7A6-322B-4DE5BDE9E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E0FFCB0-53BC-EF21-55B3-4BBB8960E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3020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1C9435-6A84-775B-01B6-8B20CD777B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605317-BE67-58BF-DDDF-D338BD19DF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63F7548-1A39-2B06-604F-ED0DB87D2B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2A8D9D-73BE-18F4-15BE-154F2E55D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FF6AF3-E78E-25AF-973B-706FA75F7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57D96EB-6977-0C4A-2ED9-21F520F9F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166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E4D6B-63B2-686B-F9FB-4AA4256B8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8D3BB20-587F-D467-EA36-D250740B42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E2537EC-7403-F53D-3F90-A745A9B26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3DBFDCD-67E6-EE6B-16BE-5D85A0273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3988C1-FF89-D16B-7C20-C2130193A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FE69643-7D6D-5B34-2474-AB1A78003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9067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707FDDC-93BD-5ED0-4299-2CA7A49CBE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3E249FF-5429-8B87-9941-81A4390A8A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EBFA4D-DD46-0480-2BC6-9187DCEED0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D0B850-11BC-406A-ADAB-90F5D4352496}" type="datetimeFigureOut">
              <a:rPr lang="zh-CN" altLang="en-US" smtClean="0"/>
              <a:t>2026/4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E5DD9E-E006-A3E9-332B-B1D02CBA6B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F6922A-89BA-5DFE-AC21-7AEAA1B016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2F6BF6-A660-4112-819C-1F6F5CDBA8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402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"/><Relationship Id="rId3" Type="http://schemas.openxmlformats.org/officeDocument/2006/relationships/image" Target="../media/image9.tif"/><Relationship Id="rId7" Type="http://schemas.openxmlformats.org/officeDocument/2006/relationships/image" Target="../media/image13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"/><Relationship Id="rId13" Type="http://schemas.openxmlformats.org/officeDocument/2006/relationships/image" Target="../media/image26.tif"/><Relationship Id="rId3" Type="http://schemas.openxmlformats.org/officeDocument/2006/relationships/image" Target="../media/image16.tif"/><Relationship Id="rId7" Type="http://schemas.openxmlformats.org/officeDocument/2006/relationships/image" Target="../media/image20.tif"/><Relationship Id="rId12" Type="http://schemas.openxmlformats.org/officeDocument/2006/relationships/image" Target="../media/image25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"/><Relationship Id="rId11" Type="http://schemas.openxmlformats.org/officeDocument/2006/relationships/image" Target="../media/image24.tif"/><Relationship Id="rId5" Type="http://schemas.openxmlformats.org/officeDocument/2006/relationships/image" Target="../media/image18.tif"/><Relationship Id="rId10" Type="http://schemas.openxmlformats.org/officeDocument/2006/relationships/image" Target="../media/image23.tif"/><Relationship Id="rId4" Type="http://schemas.openxmlformats.org/officeDocument/2006/relationships/image" Target="../media/image17.tif"/><Relationship Id="rId9" Type="http://schemas.openxmlformats.org/officeDocument/2006/relationships/image" Target="../media/image2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0" Type="http://schemas.openxmlformats.org/officeDocument/2006/relationships/image" Target="../media/image33.png"/><Relationship Id="rId4" Type="http://schemas.openxmlformats.org/officeDocument/2006/relationships/image" Target="../media/image30.png"/><Relationship Id="rId9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1350078-4B89-69F1-602C-D7147DCB7135}"/>
              </a:ext>
            </a:extLst>
          </p:cNvPr>
          <p:cNvSpPr txBox="1"/>
          <p:nvPr/>
        </p:nvSpPr>
        <p:spPr>
          <a:xfrm>
            <a:off x="73891" y="120073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DBD16AB-01A3-1AF1-F330-19350D53CFD8}"/>
              </a:ext>
            </a:extLst>
          </p:cNvPr>
          <p:cNvSpPr txBox="1"/>
          <p:nvPr/>
        </p:nvSpPr>
        <p:spPr>
          <a:xfrm>
            <a:off x="882074" y="84512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3D97E18-E7FF-B5BC-2320-5DC1E769699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19" t="18910" r="32998" b="22716"/>
          <a:stretch>
            <a:fillRect/>
          </a:stretch>
        </p:blipFill>
        <p:spPr>
          <a:xfrm>
            <a:off x="1395167" y="1338606"/>
            <a:ext cx="2498103" cy="3403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BFC75E8-0445-BDB3-2CF8-AF2A4FE9B5F0}"/>
              </a:ext>
            </a:extLst>
          </p:cNvPr>
          <p:cNvSpPr txBox="1"/>
          <p:nvPr/>
        </p:nvSpPr>
        <p:spPr>
          <a:xfrm>
            <a:off x="5518278" y="93746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AD82D09-5425-9007-7E8B-7FD04E519AC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889" t="18912" r="38234" b="24082"/>
          <a:stretch>
            <a:fillRect/>
          </a:stretch>
        </p:blipFill>
        <p:spPr>
          <a:xfrm>
            <a:off x="6294102" y="1338606"/>
            <a:ext cx="1852370" cy="327438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493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8231F4-A366-1525-4E4C-DC3289F962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9DD2EE0-158D-068E-624F-A9620909C3DE}"/>
              </a:ext>
            </a:extLst>
          </p:cNvPr>
          <p:cNvSpPr txBox="1"/>
          <p:nvPr/>
        </p:nvSpPr>
        <p:spPr>
          <a:xfrm>
            <a:off x="73891" y="12007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940E8A7-CEAE-990B-B0B3-4D29104CD7CD}"/>
              </a:ext>
            </a:extLst>
          </p:cNvPr>
          <p:cNvSpPr txBox="1"/>
          <p:nvPr/>
        </p:nvSpPr>
        <p:spPr>
          <a:xfrm>
            <a:off x="560461" y="6789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16FE8AB-E40D-3518-84FB-910B83C7019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05" t="23591" r="31840" b="15303"/>
          <a:stretch>
            <a:fillRect/>
          </a:stretch>
        </p:blipFill>
        <p:spPr>
          <a:xfrm>
            <a:off x="4987420" y="1065440"/>
            <a:ext cx="2235200" cy="2492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D7F22EB-929F-D0BF-7E0F-4C6E688F90F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63" t="9682" r="29838" b="27751"/>
          <a:stretch>
            <a:fillRect/>
          </a:stretch>
        </p:blipFill>
        <p:spPr>
          <a:xfrm>
            <a:off x="8579861" y="1065439"/>
            <a:ext cx="2403545" cy="2492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8E58C01-7CA0-DDE2-0646-9EFFEA08DB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6" t="10545" r="41385" b="23837"/>
          <a:stretch>
            <a:fillRect/>
          </a:stretch>
        </p:blipFill>
        <p:spPr>
          <a:xfrm>
            <a:off x="1376938" y="3960810"/>
            <a:ext cx="2030558" cy="26762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1214372-6317-7516-670C-789F3DA337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82" t="23851" r="31055" b="13122"/>
          <a:stretch>
            <a:fillRect/>
          </a:stretch>
        </p:blipFill>
        <p:spPr>
          <a:xfrm>
            <a:off x="4988789" y="3960810"/>
            <a:ext cx="2104597" cy="25954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32448725-A85C-CD3A-E6A7-9D1A45EC5A9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78" t="14084" r="28566" b="23492"/>
          <a:stretch>
            <a:fillRect/>
          </a:stretch>
        </p:blipFill>
        <p:spPr>
          <a:xfrm>
            <a:off x="1376938" y="1065439"/>
            <a:ext cx="2392218" cy="24929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7282D78C-28BB-F752-C023-04E2CD4CDD72}"/>
              </a:ext>
            </a:extLst>
          </p:cNvPr>
          <p:cNvSpPr txBox="1"/>
          <p:nvPr/>
        </p:nvSpPr>
        <p:spPr>
          <a:xfrm>
            <a:off x="4448681" y="1207064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6159098-F79C-99FA-5C54-03D67B161798}"/>
              </a:ext>
            </a:extLst>
          </p:cNvPr>
          <p:cNvSpPr txBox="1"/>
          <p:nvPr/>
        </p:nvSpPr>
        <p:spPr>
          <a:xfrm>
            <a:off x="7829189" y="1207064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1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8420CE1-4B9F-A0A5-9B33-4773EC264BA7}"/>
              </a:ext>
            </a:extLst>
          </p:cNvPr>
          <p:cNvSpPr txBox="1"/>
          <p:nvPr/>
        </p:nvSpPr>
        <p:spPr>
          <a:xfrm>
            <a:off x="855735" y="4571240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D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E522327-C616-8818-217C-8C671FFA2F1A}"/>
              </a:ext>
            </a:extLst>
          </p:cNvPr>
          <p:cNvSpPr txBox="1"/>
          <p:nvPr/>
        </p:nvSpPr>
        <p:spPr>
          <a:xfrm>
            <a:off x="4461164" y="4567011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H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0C29AC3-97FF-5B85-F5E1-2D8A40C3C3FF}"/>
              </a:ext>
            </a:extLst>
          </p:cNvPr>
          <p:cNvSpPr txBox="1"/>
          <p:nvPr/>
        </p:nvSpPr>
        <p:spPr>
          <a:xfrm>
            <a:off x="855735" y="1207065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A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1343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4F4B54-BC6E-F4EE-DA4F-1CDAE199A6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DDEAAF0-A9FF-453E-2E99-B5DD609D3012}"/>
              </a:ext>
            </a:extLst>
          </p:cNvPr>
          <p:cNvSpPr txBox="1"/>
          <p:nvPr/>
        </p:nvSpPr>
        <p:spPr>
          <a:xfrm>
            <a:off x="73891" y="12007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6A43EBB-D500-DD71-2D73-40850CFED60E}"/>
              </a:ext>
            </a:extLst>
          </p:cNvPr>
          <p:cNvSpPr txBox="1"/>
          <p:nvPr/>
        </p:nvSpPr>
        <p:spPr>
          <a:xfrm>
            <a:off x="560461" y="6789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5307DB1-831D-4BC9-E8C5-6109E9FBD6B8}"/>
              </a:ext>
            </a:extLst>
          </p:cNvPr>
          <p:cNvSpPr txBox="1"/>
          <p:nvPr/>
        </p:nvSpPr>
        <p:spPr>
          <a:xfrm>
            <a:off x="3571476" y="1207065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0ED6383-B55A-3D6A-A320-B4234803BBE5}"/>
              </a:ext>
            </a:extLst>
          </p:cNvPr>
          <p:cNvSpPr txBox="1"/>
          <p:nvPr/>
        </p:nvSpPr>
        <p:spPr>
          <a:xfrm>
            <a:off x="6549749" y="1207065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1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DB125C3-9FC2-717A-8181-4A9212231738}"/>
              </a:ext>
            </a:extLst>
          </p:cNvPr>
          <p:cNvSpPr txBox="1"/>
          <p:nvPr/>
        </p:nvSpPr>
        <p:spPr>
          <a:xfrm>
            <a:off x="560461" y="4571240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D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706256D-6068-9D86-436D-98FB05899762}"/>
              </a:ext>
            </a:extLst>
          </p:cNvPr>
          <p:cNvSpPr txBox="1"/>
          <p:nvPr/>
        </p:nvSpPr>
        <p:spPr>
          <a:xfrm>
            <a:off x="3583959" y="4567012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H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39CD237-8EFD-8B68-5B1E-901C47E6F034}"/>
              </a:ext>
            </a:extLst>
          </p:cNvPr>
          <p:cNvSpPr txBox="1"/>
          <p:nvPr/>
        </p:nvSpPr>
        <p:spPr>
          <a:xfrm>
            <a:off x="560461" y="1207065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A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156F687-64E2-E2C7-1A44-4177B78DB2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2" t="10537" r="33678" b="24218"/>
          <a:stretch>
            <a:fillRect/>
          </a:stretch>
        </p:blipFill>
        <p:spPr>
          <a:xfrm>
            <a:off x="4070023" y="1484064"/>
            <a:ext cx="2062740" cy="2373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9B894B6-E43F-6A66-10F7-0720EFFB84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3" t="17560" r="24604" b="11837"/>
          <a:stretch>
            <a:fillRect/>
          </a:stretch>
        </p:blipFill>
        <p:spPr>
          <a:xfrm>
            <a:off x="7076005" y="1484064"/>
            <a:ext cx="1831229" cy="2373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81E2791B-3B05-B755-6674-A2A51BA376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66" t="25478" r="30597" b="10994"/>
          <a:stretch>
            <a:fillRect/>
          </a:stretch>
        </p:blipFill>
        <p:spPr>
          <a:xfrm>
            <a:off x="1086717" y="4410364"/>
            <a:ext cx="1831229" cy="2447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3575B36-235F-0760-4D9E-3D6FEC6E425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60" t="20733" r="22505" b="12654"/>
          <a:stretch>
            <a:fillRect/>
          </a:stretch>
        </p:blipFill>
        <p:spPr>
          <a:xfrm>
            <a:off x="4097732" y="4410365"/>
            <a:ext cx="1998268" cy="2447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5AEC7B2-2865-79C1-BC40-0AE69A540C3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66" t="12818" r="32856" b="24131"/>
          <a:stretch>
            <a:fillRect/>
          </a:stretch>
        </p:blipFill>
        <p:spPr>
          <a:xfrm>
            <a:off x="7076005" y="4410364"/>
            <a:ext cx="1998267" cy="23737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BF05FEDA-53CC-507C-B274-8969E54AA4DC}"/>
              </a:ext>
            </a:extLst>
          </p:cNvPr>
          <p:cNvSpPr txBox="1"/>
          <p:nvPr/>
        </p:nvSpPr>
        <p:spPr>
          <a:xfrm>
            <a:off x="6549749" y="4567011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7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5124F9E-8F18-E396-6424-0DED117757D1}"/>
              </a:ext>
            </a:extLst>
          </p:cNvPr>
          <p:cNvSpPr txBox="1"/>
          <p:nvPr/>
        </p:nvSpPr>
        <p:spPr>
          <a:xfrm>
            <a:off x="9350910" y="4567011"/>
            <a:ext cx="703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AB8FC620-C132-08D9-B719-881A4FD7818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73" t="19860" r="31898" b="12773"/>
          <a:stretch>
            <a:fillRect/>
          </a:stretch>
        </p:blipFill>
        <p:spPr>
          <a:xfrm>
            <a:off x="10054277" y="4410364"/>
            <a:ext cx="1937941" cy="23737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屏幕上写着字&#10;&#10;AI 生成的内容可能不正确。">
            <a:extLst>
              <a:ext uri="{FF2B5EF4-FFF2-40B4-BE49-F238E27FC236}">
                <a16:creationId xmlns:a16="http://schemas.microsoft.com/office/drawing/2014/main" id="{394502D0-2109-CCB8-FE22-2754FF2902C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002" y="1445529"/>
            <a:ext cx="1954659" cy="2412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7999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F629B23-551E-BCAD-A6B8-4C70FA51697F}"/>
              </a:ext>
            </a:extLst>
          </p:cNvPr>
          <p:cNvSpPr txBox="1"/>
          <p:nvPr/>
        </p:nvSpPr>
        <p:spPr>
          <a:xfrm>
            <a:off x="73891" y="12007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4BEE903-B113-8501-79F8-8C4519C44ADB}"/>
              </a:ext>
            </a:extLst>
          </p:cNvPr>
          <p:cNvSpPr txBox="1"/>
          <p:nvPr/>
        </p:nvSpPr>
        <p:spPr>
          <a:xfrm>
            <a:off x="560461" y="6789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5">
            <a:extLst>
              <a:ext uri="{FF2B5EF4-FFF2-40B4-BE49-F238E27FC236}">
                <a16:creationId xmlns:a16="http://schemas.microsoft.com/office/drawing/2014/main" id="{E4D2415F-398F-B780-F153-275BF112A8C6}"/>
              </a:ext>
            </a:extLst>
          </p:cNvPr>
          <p:cNvSpPr txBox="1"/>
          <p:nvPr/>
        </p:nvSpPr>
        <p:spPr>
          <a:xfrm>
            <a:off x="962736" y="1007507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ti-His </a:t>
            </a:r>
            <a:r>
              <a:rPr lang="en-US" altLang="zh-CN" sz="1200" b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b</a:t>
            </a:r>
            <a:endParaRPr lang="en-US" altLang="zh-CN" sz="12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C597050C-CEA3-DDAD-3238-65260575FB72}"/>
              </a:ext>
            </a:extLst>
          </p:cNvPr>
          <p:cNvSpPr txBox="1"/>
          <p:nvPr/>
        </p:nvSpPr>
        <p:spPr>
          <a:xfrm>
            <a:off x="4226853" y="1007510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C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4CB1D89-5821-31BF-4DF7-01D45F75C8B4}"/>
              </a:ext>
            </a:extLst>
          </p:cNvPr>
          <p:cNvSpPr txBox="1"/>
          <p:nvPr/>
        </p:nvSpPr>
        <p:spPr>
          <a:xfrm>
            <a:off x="6246675" y="1007509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C10</a:t>
            </a:r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0DE4AA36-2ADA-C22F-2101-B2AD3F3F7A2C}"/>
              </a:ext>
            </a:extLst>
          </p:cNvPr>
          <p:cNvSpPr txBox="1"/>
          <p:nvPr/>
        </p:nvSpPr>
        <p:spPr>
          <a:xfrm>
            <a:off x="10159939" y="1007507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9H8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CBB5E98E-5906-22A6-C7AA-F5254C670473}"/>
              </a:ext>
            </a:extLst>
          </p:cNvPr>
          <p:cNvSpPr txBox="1"/>
          <p:nvPr/>
        </p:nvSpPr>
        <p:spPr>
          <a:xfrm>
            <a:off x="8203307" y="1007507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6D5</a:t>
            </a:r>
          </a:p>
        </p:txBody>
      </p:sp>
      <p:sp>
        <p:nvSpPr>
          <p:cNvPr id="9" name="TextBox 5">
            <a:extLst>
              <a:ext uri="{FF2B5EF4-FFF2-40B4-BE49-F238E27FC236}">
                <a16:creationId xmlns:a16="http://schemas.microsoft.com/office/drawing/2014/main" id="{C4EF7E1C-3BE4-E81F-B36B-608DFBA21E5C}"/>
              </a:ext>
            </a:extLst>
          </p:cNvPr>
          <p:cNvSpPr txBox="1"/>
          <p:nvPr/>
        </p:nvSpPr>
        <p:spPr>
          <a:xfrm>
            <a:off x="2500114" y="1007509"/>
            <a:ext cx="1071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A5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C22FAA39-D756-D714-B8B4-883C06FC8F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59" t="15823" r="30598" b="16688"/>
          <a:stretch>
            <a:fillRect/>
          </a:stretch>
        </p:blipFill>
        <p:spPr>
          <a:xfrm>
            <a:off x="922093" y="1539166"/>
            <a:ext cx="1153214" cy="1506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207EE55-F17C-225C-7376-2E56B25FAA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25" t="28893" r="31606" b="10070"/>
          <a:stretch>
            <a:fillRect/>
          </a:stretch>
        </p:blipFill>
        <p:spPr>
          <a:xfrm>
            <a:off x="2725322" y="1539166"/>
            <a:ext cx="1155327" cy="1506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15FA069-089E-4431-1CD5-5D240B9408F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8" t="24965" r="29390" b="14223"/>
          <a:stretch>
            <a:fillRect/>
          </a:stretch>
        </p:blipFill>
        <p:spPr>
          <a:xfrm>
            <a:off x="4550477" y="1539168"/>
            <a:ext cx="1163686" cy="1506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B87E8B8-E14E-0D66-318C-7DF9D9923BD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93" t="29027" r="35432" b="12096"/>
          <a:stretch>
            <a:fillRect/>
          </a:stretch>
        </p:blipFill>
        <p:spPr>
          <a:xfrm>
            <a:off x="6477839" y="1539167"/>
            <a:ext cx="1153213" cy="1506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EE483FB-885C-0B2C-9CBD-CDE35FC59AB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15" t="31566" r="34143" b="16793"/>
          <a:stretch>
            <a:fillRect/>
          </a:stretch>
        </p:blipFill>
        <p:spPr>
          <a:xfrm>
            <a:off x="8394728" y="1539166"/>
            <a:ext cx="1433604" cy="15060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C437FB0-6DC4-6E97-85AD-9B52137BE8F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81" t="30784" r="39314" b="10371"/>
          <a:stretch>
            <a:fillRect/>
          </a:stretch>
        </p:blipFill>
        <p:spPr>
          <a:xfrm>
            <a:off x="10497790" y="1539166"/>
            <a:ext cx="1071928" cy="15060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E1ED192-ABB0-8BA1-48A2-26DCFFB3AA4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30" t="23288" r="10744" b="11263"/>
          <a:stretch>
            <a:fillRect/>
          </a:stretch>
        </p:blipFill>
        <p:spPr>
          <a:xfrm>
            <a:off x="708098" y="3428997"/>
            <a:ext cx="1581204" cy="10710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DEB92E8-437C-563A-EB26-E985196AF46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07" t="13006" r="6823" b="25344"/>
          <a:stretch>
            <a:fillRect/>
          </a:stretch>
        </p:blipFill>
        <p:spPr>
          <a:xfrm>
            <a:off x="4257910" y="3428997"/>
            <a:ext cx="1748819" cy="10710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F24A9189-DCAA-91B3-9DC8-8C5E74ED336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24" t="26851" r="7212" b="19221"/>
          <a:stretch>
            <a:fillRect/>
          </a:stretch>
        </p:blipFill>
        <p:spPr>
          <a:xfrm>
            <a:off x="6112491" y="3428996"/>
            <a:ext cx="1962038" cy="10710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181F7502-B89B-1261-B0C2-5047CC955BC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2" t="30949" r="11677" b="10556"/>
          <a:stretch>
            <a:fillRect/>
          </a:stretch>
        </p:blipFill>
        <p:spPr>
          <a:xfrm>
            <a:off x="8164921" y="3428997"/>
            <a:ext cx="1904626" cy="10732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5689AE03-0903-DBF2-0FDB-6520BB3992C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92" t="16675" r="7452" b="22865"/>
          <a:stretch>
            <a:fillRect/>
          </a:stretch>
        </p:blipFill>
        <p:spPr>
          <a:xfrm>
            <a:off x="10159939" y="3428996"/>
            <a:ext cx="1798542" cy="10710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8BFE30E-F5FA-6A5C-71E1-492968DF1FA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7" t="17026" r="12645" b="22694"/>
          <a:stretch>
            <a:fillRect/>
          </a:stretch>
        </p:blipFill>
        <p:spPr>
          <a:xfrm>
            <a:off x="2429738" y="3428996"/>
            <a:ext cx="1687735" cy="107100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752415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8DCE73D-1502-1100-0DCE-317996B46A13}"/>
              </a:ext>
            </a:extLst>
          </p:cNvPr>
          <p:cNvSpPr txBox="1"/>
          <p:nvPr/>
        </p:nvSpPr>
        <p:spPr>
          <a:xfrm>
            <a:off x="73891" y="12007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67B018E-1E45-DBAA-5FF1-B3FDF8C7F7FB}"/>
              </a:ext>
            </a:extLst>
          </p:cNvPr>
          <p:cNvSpPr txBox="1"/>
          <p:nvPr/>
        </p:nvSpPr>
        <p:spPr>
          <a:xfrm>
            <a:off x="861286" y="12239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4FFC6B1-022D-F213-FC92-190FFFF27E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89" t="30657" r="38708" b="9901"/>
          <a:stretch>
            <a:fillRect/>
          </a:stretch>
        </p:blipFill>
        <p:spPr>
          <a:xfrm>
            <a:off x="3620655" y="1584121"/>
            <a:ext cx="1191489" cy="21935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F9DD2A5-DA44-598C-56A2-714707F73C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12" t="28512" r="26086" b="17351"/>
          <a:stretch>
            <a:fillRect/>
          </a:stretch>
        </p:blipFill>
        <p:spPr>
          <a:xfrm>
            <a:off x="1209963" y="1584121"/>
            <a:ext cx="1793149" cy="21935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FC328F5-04C5-0AC8-958B-617F2DD4BC40}"/>
              </a:ext>
            </a:extLst>
          </p:cNvPr>
          <p:cNvSpPr txBox="1"/>
          <p:nvPr/>
        </p:nvSpPr>
        <p:spPr>
          <a:xfrm>
            <a:off x="3473018" y="12239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2919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4A6BB30-1511-5B6B-6AD0-BB782A515998}"/>
              </a:ext>
            </a:extLst>
          </p:cNvPr>
          <p:cNvSpPr txBox="1"/>
          <p:nvPr/>
        </p:nvSpPr>
        <p:spPr>
          <a:xfrm>
            <a:off x="73891" y="120073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8DC0B49-273D-5EEE-DAAC-B460B1E21C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202" t="40982" r="35856" b="2621"/>
          <a:stretch>
            <a:fillRect/>
          </a:stretch>
        </p:blipFill>
        <p:spPr>
          <a:xfrm>
            <a:off x="914400" y="1015999"/>
            <a:ext cx="1311564" cy="20504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CA8E5A2-B1B5-4540-B154-42E19DF4675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545" t="21999" r="42453" b="20691"/>
          <a:stretch>
            <a:fillRect/>
          </a:stretch>
        </p:blipFill>
        <p:spPr>
          <a:xfrm>
            <a:off x="2660072" y="1015999"/>
            <a:ext cx="1560945" cy="20504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113CFBB-20F6-B2C9-FDBF-D7A9F298F30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365" t="30072" r="35456" b="14264"/>
          <a:stretch>
            <a:fillRect/>
          </a:stretch>
        </p:blipFill>
        <p:spPr>
          <a:xfrm>
            <a:off x="4572000" y="1015998"/>
            <a:ext cx="1385455" cy="20504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8738A79-562C-8A3A-7C29-3919A72A0FF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651" t="23283" r="42390" b="19462"/>
          <a:stretch>
            <a:fillRect/>
          </a:stretch>
        </p:blipFill>
        <p:spPr>
          <a:xfrm>
            <a:off x="6437745" y="1015998"/>
            <a:ext cx="1337263" cy="20504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905E259-9FB3-B42A-7049-83CE822AEBB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653" t="31741" r="43337" b="18061"/>
          <a:stretch>
            <a:fillRect/>
          </a:stretch>
        </p:blipFill>
        <p:spPr>
          <a:xfrm>
            <a:off x="8303491" y="1015998"/>
            <a:ext cx="1426046" cy="20504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0B3DA9D5-DFFF-84D5-8738-76B4900570B4}"/>
              </a:ext>
            </a:extLst>
          </p:cNvPr>
          <p:cNvSpPr txBox="1"/>
          <p:nvPr/>
        </p:nvSpPr>
        <p:spPr>
          <a:xfrm>
            <a:off x="3177416" y="699064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0E210B6-D285-8270-D6D0-10346BBB4A36}"/>
              </a:ext>
            </a:extLst>
          </p:cNvPr>
          <p:cNvSpPr txBox="1"/>
          <p:nvPr/>
        </p:nvSpPr>
        <p:spPr>
          <a:xfrm>
            <a:off x="5007271" y="705401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C1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692F521-215A-A88F-C6AB-C9FEDF94B3F5}"/>
              </a:ext>
            </a:extLst>
          </p:cNvPr>
          <p:cNvSpPr txBox="1"/>
          <p:nvPr/>
        </p:nvSpPr>
        <p:spPr>
          <a:xfrm>
            <a:off x="6843248" y="699064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D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ECD0716-C894-A360-B8B8-CF6C10CD6658}"/>
              </a:ext>
            </a:extLst>
          </p:cNvPr>
          <p:cNvSpPr txBox="1"/>
          <p:nvPr/>
        </p:nvSpPr>
        <p:spPr>
          <a:xfrm>
            <a:off x="8753386" y="699064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H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2FB1463-D760-B551-153D-800BAF42308B}"/>
              </a:ext>
            </a:extLst>
          </p:cNvPr>
          <p:cNvSpPr txBox="1"/>
          <p:nvPr/>
        </p:nvSpPr>
        <p:spPr>
          <a:xfrm>
            <a:off x="1364024" y="699065"/>
            <a:ext cx="526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A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1319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43</Words>
  <Application>Microsoft Office PowerPoint</Application>
  <PresentationFormat>宽屏</PresentationFormat>
  <Paragraphs>3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y Gao</dc:creator>
  <cp:lastModifiedBy>Jenny Gao</cp:lastModifiedBy>
  <cp:revision>5</cp:revision>
  <dcterms:created xsi:type="dcterms:W3CDTF">2026-02-07T05:16:05Z</dcterms:created>
  <dcterms:modified xsi:type="dcterms:W3CDTF">2026-04-28T04:55:22Z</dcterms:modified>
</cp:coreProperties>
</file>